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59" r:id="rId3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18" userDrawn="1">
          <p15:clr>
            <a:srgbClr val="A4A3A4"/>
          </p15:clr>
        </p15:guide>
        <p15:guide id="2" pos="5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248" y="114"/>
      </p:cViewPr>
      <p:guideLst>
        <p:guide orient="horz" pos="618"/>
        <p:guide pos="5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39077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65729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0994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21366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0896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8464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861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4822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5788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3177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415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868C28-6776-440A-87CF-941375A0CE68}" type="datetimeFigureOut">
              <a:rPr lang="en-GB" smtClean="0"/>
              <a:t>17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65E2B7-AA36-4E24-95C4-27BD76884BB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65950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507724" y="130602"/>
            <a:ext cx="9214753" cy="6769684"/>
            <a:chOff x="507724" y="130602"/>
            <a:chExt cx="9214753" cy="6769684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04670" y="130602"/>
              <a:ext cx="7715660" cy="3638682"/>
            </a:xfrm>
            <a:prstGeom prst="rect">
              <a:avLst/>
            </a:prstGeom>
          </p:spPr>
        </p:pic>
        <p:grpSp>
          <p:nvGrpSpPr>
            <p:cNvPr id="14" name="Group 13"/>
            <p:cNvGrpSpPr/>
            <p:nvPr/>
          </p:nvGrpSpPr>
          <p:grpSpPr>
            <a:xfrm>
              <a:off x="507724" y="3707874"/>
              <a:ext cx="8944190" cy="3192412"/>
              <a:chOff x="189317" y="3616456"/>
              <a:chExt cx="8944190" cy="3192412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189317" y="3616456"/>
                <a:ext cx="8944190" cy="3192412"/>
                <a:chOff x="409752" y="3796066"/>
                <a:chExt cx="8944190" cy="3192412"/>
              </a:xfrm>
            </p:grpSpPr>
            <p:sp>
              <p:nvSpPr>
                <p:cNvPr id="3" name="TextBox 55"/>
                <p:cNvSpPr txBox="1"/>
                <p:nvPr/>
              </p:nvSpPr>
              <p:spPr>
                <a:xfrm>
                  <a:off x="409752" y="3796066"/>
                  <a:ext cx="405109" cy="3020186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 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D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E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F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G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I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J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K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M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O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.</a:t>
                  </a:r>
                </a:p>
                <a:p>
                  <a:r>
                    <a:rPr lang="en-GB" sz="1100" b="1" dirty="0" smtClean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 </a:t>
                  </a:r>
                  <a:endParaRPr lang="en-GB" sz="1100" b="1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</p:txBody>
            </p:sp>
            <p:sp>
              <p:nvSpPr>
                <p:cNvPr id="4" name="TextBox 56"/>
                <p:cNvSpPr txBox="1"/>
                <p:nvPr/>
              </p:nvSpPr>
              <p:spPr>
                <a:xfrm>
                  <a:off x="639321" y="3796066"/>
                  <a:ext cx="1738489" cy="3192412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eaf D</a:t>
                  </a:r>
                  <a:endParaRPr lang="en-GB" sz="11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hotosynthesi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Extracellular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Organelle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ucleotide metabolism</a:t>
                  </a:r>
                </a:p>
                <a:p>
                  <a:r>
                    <a:rPr lang="en-GB" sz="1100" dirty="0" err="1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hosphotase</a:t>
                  </a:r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activit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esponse to stimulu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arbohydrate </a:t>
                  </a:r>
                  <a:r>
                    <a:rPr lang="en-GB" sz="1100" dirty="0" err="1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yase</a:t>
                  </a:r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activit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Transmembrane transport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ADP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mino acid metabolism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Ungrouped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arbohydrate metabolism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rotein phosphorylation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Metal ion binding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ell peripher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ucleotide </a:t>
                  </a:r>
                  <a:r>
                    <a:rPr lang="en-GB" sz="1100" dirty="0" smtClean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inding</a:t>
                  </a:r>
                  <a:endParaRPr lang="en-GB" sz="11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</p:txBody>
            </p:sp>
            <p:sp>
              <p:nvSpPr>
                <p:cNvPr id="5" name="TextBox 53"/>
                <p:cNvSpPr txBox="1"/>
                <p:nvPr/>
              </p:nvSpPr>
              <p:spPr>
                <a:xfrm>
                  <a:off x="2584867" y="3796066"/>
                  <a:ext cx="1700275" cy="2604583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eaf U</a:t>
                  </a:r>
                  <a:endParaRPr lang="en-GB" sz="11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  <a:p>
                  <a:r>
                    <a:rPr lang="en-GB" sz="1100" dirty="0" err="1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Glycosyl</a:t>
                  </a:r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transferase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esponse to stimulus</a:t>
                  </a:r>
                </a:p>
                <a:p>
                  <a:r>
                    <a:rPr lang="en-GB" sz="1100" dirty="0" err="1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Oxidoreducase</a:t>
                  </a:r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activit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ipid metabolic proces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Organic acid metabolism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arbohydrate metabolism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Signalling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Transmembrane transport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Metal ion binding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ell peripher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Ungrouped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hotosynthesi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mino acid metabolism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ucleotide </a:t>
                  </a:r>
                  <a:r>
                    <a:rPr lang="en-GB" sz="1100" dirty="0" smtClean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inding</a:t>
                  </a:r>
                  <a:endParaRPr lang="en-GB" sz="11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</p:txBody>
            </p:sp>
            <p:sp>
              <p:nvSpPr>
                <p:cNvPr id="6" name="TextBox 54"/>
                <p:cNvSpPr txBox="1"/>
                <p:nvPr/>
              </p:nvSpPr>
              <p:spPr>
                <a:xfrm>
                  <a:off x="2307472" y="3796066"/>
                  <a:ext cx="379136" cy="2645405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 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D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E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F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G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I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J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K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M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.  </a:t>
                  </a:r>
                </a:p>
              </p:txBody>
            </p:sp>
            <p:sp>
              <p:nvSpPr>
                <p:cNvPr id="7" name="TextBox 51"/>
                <p:cNvSpPr txBox="1"/>
                <p:nvPr/>
              </p:nvSpPr>
              <p:spPr>
                <a:xfrm>
                  <a:off x="4574022" y="3796066"/>
                  <a:ext cx="2051267" cy="278419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oot D</a:t>
                  </a:r>
                  <a:endParaRPr lang="en-GB" sz="1100" dirty="0">
                    <a:solidFill>
                      <a:sysClr val="windowText" lastClr="000000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ytoskeleton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mino acid metabolism</a:t>
                  </a:r>
                </a:p>
                <a:p>
                  <a:pPr marL="0" marR="0" lvl="0" indent="0" defTabSz="91440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ell-cell junctions</a:t>
                  </a:r>
                  <a:endParaRPr lang="en-GB" dirty="0">
                    <a:solidFill>
                      <a:sysClr val="windowText" lastClr="000000"/>
                    </a:solidFill>
                    <a:effectLst/>
                  </a:endParaRP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esponse to chemical stress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ntioxidant activity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Ion binding</a:t>
                  </a:r>
                </a:p>
                <a:p>
                  <a:r>
                    <a:rPr lang="en-GB" sz="1100" dirty="0" err="1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eme</a:t>
                  </a:r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binding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ell wall and extracellular region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ucleotide binding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hosphotransferase activity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Protein phosphorylation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Ungrouped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ell periphery</a:t>
                  </a:r>
                </a:p>
                <a:p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arbohydrate metabolism</a:t>
                  </a:r>
                </a:p>
                <a:p>
                  <a:r>
                    <a:rPr lang="en-GB" sz="1100" dirty="0" err="1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Glycosyl</a:t>
                  </a:r>
                  <a:r>
                    <a:rPr lang="en-GB" sz="1100" dirty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hydrolase </a:t>
                  </a:r>
                  <a:r>
                    <a:rPr lang="en-GB" sz="1100" dirty="0" smtClean="0">
                      <a:solidFill>
                        <a:sysClr val="windowText" lastClr="000000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ctivity</a:t>
                  </a:r>
                  <a:endParaRPr lang="en-GB" sz="1100" dirty="0">
                    <a:solidFill>
                      <a:sysClr val="windowText" lastClr="000000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</p:txBody>
            </p:sp>
            <p:sp>
              <p:nvSpPr>
                <p:cNvPr id="8" name="TextBox 52"/>
                <p:cNvSpPr txBox="1"/>
                <p:nvPr/>
              </p:nvSpPr>
              <p:spPr>
                <a:xfrm>
                  <a:off x="4334888" y="3796066"/>
                  <a:ext cx="396111" cy="2784198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 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D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E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F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G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I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J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K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L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M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O. </a:t>
                  </a:r>
                </a:p>
              </p:txBody>
            </p:sp>
            <p:sp>
              <p:nvSpPr>
                <p:cNvPr id="9" name="TextBox 49"/>
                <p:cNvSpPr txBox="1"/>
                <p:nvPr/>
              </p:nvSpPr>
              <p:spPr>
                <a:xfrm>
                  <a:off x="6848256" y="3796066"/>
                  <a:ext cx="2505686" cy="2331279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oot U</a:t>
                  </a:r>
                  <a:endParaRPr lang="en-GB" sz="11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Negative regulation of peptidase activit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Transmembrane transport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esponse to stimulu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omeostasi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ell peripher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Transferase activit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Response to chemical stress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Oxidoreductase activity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Ion binding</a:t>
                  </a:r>
                </a:p>
                <a:p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Ungrouped</a:t>
                  </a:r>
                </a:p>
                <a:p>
                  <a:r>
                    <a:rPr lang="en-GB" sz="1100" dirty="0" err="1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eme</a:t>
                  </a:r>
                  <a:r>
                    <a:rPr lang="en-GB" sz="1100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 </a:t>
                  </a:r>
                  <a:r>
                    <a:rPr lang="en-GB" sz="1100" dirty="0" smtClean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inding</a:t>
                  </a:r>
                  <a:endParaRPr lang="en-GB" sz="1100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endParaRPr>
                </a:p>
              </p:txBody>
            </p:sp>
            <p:sp>
              <p:nvSpPr>
                <p:cNvPr id="10" name="TextBox 50"/>
                <p:cNvSpPr txBox="1"/>
                <p:nvPr/>
              </p:nvSpPr>
              <p:spPr>
                <a:xfrm>
                  <a:off x="6580426" y="3796066"/>
                  <a:ext cx="444432" cy="2331279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square" rtlCol="0" anchor="t">
                  <a:no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 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A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B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C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D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E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F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G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H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I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J.  </a:t>
                  </a:r>
                </a:p>
                <a:p>
                  <a:r>
                    <a:rPr lang="en-GB" sz="1100" b="1" dirty="0">
                      <a:solidFill>
                        <a:schemeClr val="tx1"/>
                      </a:solidFill>
                      <a:effectLst/>
                      <a:latin typeface="+mn-lt"/>
                      <a:ea typeface="+mn-ea"/>
                      <a:cs typeface="+mn-cs"/>
                    </a:rPr>
                    <a:t>K. </a:t>
                  </a:r>
                </a:p>
              </p:txBody>
            </p:sp>
          </p:grpSp>
          <p:sp>
            <p:nvSpPr>
              <p:cNvPr id="12" name="TextBox 49"/>
              <p:cNvSpPr txBox="1"/>
              <p:nvPr/>
            </p:nvSpPr>
            <p:spPr>
              <a:xfrm>
                <a:off x="6627821" y="5699144"/>
                <a:ext cx="842500" cy="950101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non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100" b="1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Average</a:t>
                </a:r>
                <a:endParaRPr lang="en-GB" sz="1100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  <a:p>
                <a:r>
                  <a:rPr lang="en-GB" sz="11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Leaf D</a:t>
                </a:r>
                <a:endParaRPr lang="en-GB" sz="1100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  <a:p>
                <a:r>
                  <a:rPr lang="en-GB" sz="11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Leaf U</a:t>
                </a:r>
                <a:endParaRPr lang="en-GB" sz="1100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  <a:p>
                <a:r>
                  <a:rPr lang="en-GB" sz="11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Root D</a:t>
                </a:r>
                <a:endParaRPr lang="en-GB" sz="1100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  <a:p>
                <a:r>
                  <a:rPr lang="en-GB" sz="1100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Root U</a:t>
                </a:r>
                <a:endParaRPr lang="en-GB" sz="1100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</p:txBody>
          </p:sp>
          <p:sp>
            <p:nvSpPr>
              <p:cNvPr id="13" name="TextBox 50"/>
              <p:cNvSpPr txBox="1"/>
              <p:nvPr/>
            </p:nvSpPr>
            <p:spPr>
              <a:xfrm>
                <a:off x="6359991" y="5693340"/>
                <a:ext cx="444432" cy="933773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rtlCol="0" anchor="t">
                <a:no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GB" sz="1100" b="1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 </a:t>
                </a:r>
              </a:p>
              <a:p>
                <a:r>
                  <a:rPr lang="en-GB" sz="1100" b="1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A.  </a:t>
                </a:r>
              </a:p>
              <a:p>
                <a:r>
                  <a:rPr lang="en-GB" sz="1100" b="1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B.  </a:t>
                </a:r>
              </a:p>
              <a:p>
                <a:r>
                  <a:rPr lang="en-GB" sz="1100" b="1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C.  </a:t>
                </a:r>
              </a:p>
              <a:p>
                <a:r>
                  <a:rPr lang="en-GB" sz="1100" b="1" dirty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D.  </a:t>
                </a:r>
              </a:p>
              <a:p>
                <a:r>
                  <a:rPr lang="en-GB" sz="1100" b="1" dirty="0" smtClean="0">
                    <a:solidFill>
                      <a:schemeClr val="tx1"/>
                    </a:solidFill>
                    <a:effectLst/>
                    <a:latin typeface="+mn-lt"/>
                    <a:ea typeface="+mn-ea"/>
                    <a:cs typeface="+mn-cs"/>
                  </a:rPr>
                  <a:t>. </a:t>
                </a:r>
                <a:endParaRPr lang="en-GB" sz="1100" b="1" dirty="0">
                  <a:solidFill>
                    <a:schemeClr val="tx1"/>
                  </a:solidFill>
                  <a:effectLst/>
                  <a:latin typeface="+mn-lt"/>
                  <a:ea typeface="+mn-ea"/>
                  <a:cs typeface="+mn-cs"/>
                </a:endParaRP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8056760" y="6039153"/>
              <a:ext cx="1665717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dirty="0" smtClean="0"/>
                <a:t>For legend see next slide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12334012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7"/>
          <p:cNvSpPr txBox="1"/>
          <p:nvPr/>
        </p:nvSpPr>
        <p:spPr>
          <a:xfrm>
            <a:off x="519793" y="471410"/>
            <a:ext cx="8877300" cy="2314922"/>
          </a:xfrm>
          <a:prstGeom prst="rect">
            <a:avLst/>
          </a:prstGeom>
          <a:solidFill>
            <a:schemeClr val="lt1"/>
          </a:solidFill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800" b="1" dirty="0" smtClean="0"/>
              <a:t>S2 Fig.  </a:t>
            </a:r>
            <a:r>
              <a:rPr lang="en-GB" sz="1800" dirty="0" smtClean="0"/>
              <a:t>The </a:t>
            </a:r>
            <a:r>
              <a:rPr lang="en-GB" sz="1800" dirty="0"/>
              <a:t>percentage</a:t>
            </a:r>
            <a:r>
              <a:rPr lang="en-GB" sz="1800" baseline="0" dirty="0"/>
              <a:t> </a:t>
            </a:r>
            <a:r>
              <a:rPr lang="en-GB" sz="1800" baseline="0" dirty="0" smtClean="0"/>
              <a:t>proportion</a:t>
            </a:r>
            <a:r>
              <a:rPr lang="en-GB" sz="1800" dirty="0" smtClean="0"/>
              <a:t> </a:t>
            </a:r>
            <a:r>
              <a:rPr lang="en-GB" sz="1800" baseline="0" dirty="0" smtClean="0"/>
              <a:t>of </a:t>
            </a:r>
            <a:r>
              <a:rPr lang="en-GB" sz="1800" baseline="0" dirty="0"/>
              <a:t>the total number of </a:t>
            </a:r>
            <a:r>
              <a:rPr lang="en-GB" sz="1800" baseline="0" dirty="0" smtClean="0"/>
              <a:t>differentially expressed genes (DEGs) </a:t>
            </a:r>
            <a:r>
              <a:rPr lang="en-GB" sz="1800" baseline="0" dirty="0"/>
              <a:t>enriching </a:t>
            </a:r>
            <a:r>
              <a:rPr lang="en-GB" sz="1800" dirty="0" smtClean="0"/>
              <a:t>the gene ontology (</a:t>
            </a:r>
            <a:r>
              <a:rPr lang="en-GB" sz="1800" baseline="0" dirty="0" smtClean="0"/>
              <a:t>GO) </a:t>
            </a:r>
            <a:r>
              <a:rPr lang="en-GB" sz="1800" baseline="0" dirty="0"/>
              <a:t>terms within </a:t>
            </a:r>
            <a:r>
              <a:rPr lang="en-GB" sz="1800" baseline="0" dirty="0" smtClean="0"/>
              <a:t>particular GO </a:t>
            </a:r>
            <a:r>
              <a:rPr lang="en-GB" sz="1800" baseline="0" dirty="0"/>
              <a:t>groups across all 4 genotypes that are DEGs in every genotype. GOs enriched by &lt;10 DEGs for any genotype and groups represented by only 1 GO </a:t>
            </a:r>
            <a:r>
              <a:rPr lang="en-GB" sz="1800" baseline="0" dirty="0" smtClean="0"/>
              <a:t>term are </a:t>
            </a:r>
            <a:r>
              <a:rPr lang="en-GB" sz="1800" baseline="0" dirty="0"/>
              <a:t>excluded</a:t>
            </a:r>
            <a:r>
              <a:rPr lang="en-GB" sz="1800" baseline="0" dirty="0" smtClean="0"/>
              <a:t>.  </a:t>
            </a:r>
            <a:r>
              <a:rPr lang="en-GB" sz="1800" b="1" baseline="0" dirty="0" smtClean="0"/>
              <a:t>Leaf D</a:t>
            </a:r>
            <a:r>
              <a:rPr lang="en-GB" sz="1800" baseline="0" dirty="0" smtClean="0"/>
              <a:t>, </a:t>
            </a:r>
            <a:r>
              <a:rPr lang="en-GB" sz="1800" b="1" baseline="0" dirty="0" smtClean="0"/>
              <a:t>Leaf U</a:t>
            </a:r>
            <a:r>
              <a:rPr lang="en-GB" sz="1800" baseline="0" dirty="0" smtClean="0"/>
              <a:t>, </a:t>
            </a:r>
            <a:r>
              <a:rPr lang="en-GB" sz="1800" b="1" baseline="0" dirty="0" smtClean="0"/>
              <a:t>Root D</a:t>
            </a:r>
            <a:r>
              <a:rPr lang="en-GB" sz="1800" baseline="0" dirty="0" smtClean="0"/>
              <a:t> and </a:t>
            </a:r>
            <a:r>
              <a:rPr lang="en-GB" sz="1800" b="1" baseline="0" dirty="0" smtClean="0"/>
              <a:t>Root U</a:t>
            </a:r>
            <a:r>
              <a:rPr lang="en-GB" sz="1800" baseline="0" dirty="0" smtClean="0"/>
              <a:t> = GO term</a:t>
            </a:r>
            <a:r>
              <a:rPr lang="en-GB" sz="1800" dirty="0" smtClean="0"/>
              <a:t> groups</a:t>
            </a:r>
            <a:r>
              <a:rPr lang="en-GB" sz="1800" baseline="0" dirty="0" smtClean="0"/>
              <a:t> enriched by leaf d-DEGs, leaf u-DEGs, root </a:t>
            </a:r>
            <a:r>
              <a:rPr lang="en-GB" sz="1800" baseline="0" dirty="0" smtClean="0"/>
              <a:t>d-DEGs</a:t>
            </a:r>
            <a:r>
              <a:rPr lang="en-GB" sz="1800" baseline="0" dirty="0" smtClean="0"/>
              <a:t>, and root </a:t>
            </a:r>
            <a:r>
              <a:rPr lang="en-GB" sz="1800" baseline="0" dirty="0" smtClean="0"/>
              <a:t>up-DEGs</a:t>
            </a:r>
            <a:r>
              <a:rPr lang="en-GB" sz="1800" baseline="0" dirty="0" smtClean="0"/>
              <a:t>, respectively. Error bars for the average scores are standard errors. The letter labels on the </a:t>
            </a:r>
            <a:r>
              <a:rPr lang="en-GB" sz="1800" i="1" baseline="0" dirty="0" smtClean="0"/>
              <a:t>x</a:t>
            </a:r>
            <a:r>
              <a:rPr lang="en-GB" sz="1800" baseline="0" dirty="0" smtClean="0"/>
              <a:t> axis refer to the GO groups described below</a:t>
            </a:r>
            <a:r>
              <a:rPr lang="en-GB" sz="1800" dirty="0" smtClean="0"/>
              <a:t> for each tissue expression category.</a:t>
            </a:r>
            <a:r>
              <a:rPr lang="en-GB" sz="1800" baseline="0" dirty="0"/>
              <a:t/>
            </a:r>
            <a:br>
              <a:rPr lang="en-GB" sz="1800" baseline="0" dirty="0"/>
            </a:br>
            <a:endParaRPr lang="en-GB" sz="1800" dirty="0"/>
          </a:p>
        </p:txBody>
      </p:sp>
    </p:spTree>
    <p:extLst>
      <p:ext uri="{BB962C8B-B14F-4D97-AF65-F5344CB8AC3E}">
        <p14:creationId xmlns:p14="http://schemas.microsoft.com/office/powerpoint/2010/main" val="3404672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55</TotalTime>
  <Words>394</Words>
  <Application>Microsoft Office PowerPoint</Application>
  <PresentationFormat>A4 Paper (210x297 mm)</PresentationFormat>
  <Paragraphs>13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xx</dc:creator>
  <cp:lastModifiedBy>xxx</cp:lastModifiedBy>
  <cp:revision>19</cp:revision>
  <dcterms:created xsi:type="dcterms:W3CDTF">2020-09-29T13:06:25Z</dcterms:created>
  <dcterms:modified xsi:type="dcterms:W3CDTF">2021-03-17T05:29:48Z</dcterms:modified>
</cp:coreProperties>
</file>